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4AF07-2B2D-4CB2-829D-5532DC68C8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A2C70B-E370-43DF-B141-011F544771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2B4FF-BF6D-420E-8848-835ADBEA1A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C972B-CDBD-41FE-860C-1B7C73D8EA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3E5C8-EEE0-4084-B3BA-4D5C5331E6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39082-27E9-4BDE-8357-F7D8F9657B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EEA96E-ACEF-494A-9AE0-F0B56D0357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17F5D-64A8-43A4-9669-F4299B1146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F6304-2C8A-429E-AD55-5323DF11F8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462713-A56D-45AA-9AA8-793A827270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CADEF-0E94-46D2-9374-E958B3B126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CDC7C5-3948-4F90-BBA5-098D6E36F7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8EF6BE-05B1-4334-8537-DC840F6E017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285840" y="428760"/>
            <a:ext cx="850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3. Bias plots for SINO genes in Lee data using procedure 3 and comparing with reweighting method and mseq method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285840" y="1357200"/>
            <a:ext cx="8550360" cy="4923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32:10Z</dcterms:created>
  <dc:creator>Wei Zheng</dc:creator>
  <dc:description/>
  <dc:language>en-US</dc:language>
  <cp:lastModifiedBy>Wei Zheng</cp:lastModifiedBy>
  <dcterms:modified xsi:type="dcterms:W3CDTF">2011-06-06T17:32:21Z</dcterms:modified>
  <cp:revision>1</cp:revision>
  <dc:subject/>
  <dc:title>Slide 1</dc:title>
</cp:coreProperties>
</file>